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72FA9C-4511-4F81-A9A2-CC33951B02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FD0F660-DED0-4005-A63D-BAFABDCA455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29AEE4-59BF-4788-B5FB-4CB7161D2F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C564-C670-4CB8-9A64-5039F3822A41}" type="datetimeFigureOut">
              <a:rPr lang="en-US" smtClean="0"/>
              <a:t>12/1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1EB575-3DB1-4E9C-8966-2B6597C0C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18768E-0606-4C6A-B3D4-9D77F42BF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FD73-7408-405F-8F3A-83B50265A9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465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33513C-2E73-4744-93BB-AB1656D985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CE8E6B-625F-427C-8B36-CC5F4C2DEF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6AC2BE-0A13-470A-BA18-BDAA8763F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C564-C670-4CB8-9A64-5039F3822A41}" type="datetimeFigureOut">
              <a:rPr lang="en-US" smtClean="0"/>
              <a:t>12/1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BDC831-590A-4CDC-81B9-1C235FCA4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4A069E-0932-4FBA-B9A4-427158DB74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FD73-7408-405F-8F3A-83B50265A9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233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8537558-A780-4D7A-B021-0E56AB7A3A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5AFBE5-91B1-4E70-8CD8-95DD2E3F4E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090930-7343-4C43-9E52-837CCC8DE0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C564-C670-4CB8-9A64-5039F3822A41}" type="datetimeFigureOut">
              <a:rPr lang="en-US" smtClean="0"/>
              <a:t>12/1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790854-B615-4089-B6E4-6AD35B4DDE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5A1C50-F0B4-4307-8413-2CB1383F9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FD73-7408-405F-8F3A-83B50265A9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418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17122A-F9CF-42A8-985E-41FA4F6C7D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944F07-B9A8-49F5-B1E1-D7688D8F37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93CD9-A4BD-447E-9D64-EF020A0599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C564-C670-4CB8-9A64-5039F3822A41}" type="datetimeFigureOut">
              <a:rPr lang="en-US" smtClean="0"/>
              <a:t>12/1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787B4A-BF64-4C50-A55F-5AF239BAE8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B872BF-1A1F-428A-832F-7DB7511632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FD73-7408-405F-8F3A-83B50265A9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975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083DCD-14DF-4C15-946C-9AAD1A430B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369EF6-DDD9-4746-A75B-3D7A9EB3F9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134EE1-ECA0-42DA-9E9F-B8E2D920A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C564-C670-4CB8-9A64-5039F3822A41}" type="datetimeFigureOut">
              <a:rPr lang="en-US" smtClean="0"/>
              <a:t>12/1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762A1B-AFB8-4B75-9BD3-A97F36574C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C05C13-7BA9-4978-94F2-84DA41234E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FD73-7408-405F-8F3A-83B50265A9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9024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9AEF0C-9FF2-4AC3-AD4E-9BC61398FB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273F70-9300-4118-86C6-35227EBC05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AE59E6-0FBD-4799-892B-7E5D4ED336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25E3C2-5C75-4EC5-97FB-F214B09240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C564-C670-4CB8-9A64-5039F3822A41}" type="datetimeFigureOut">
              <a:rPr lang="en-US" smtClean="0"/>
              <a:t>12/10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9BF26B-1382-4154-9230-31B0C2F834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DC0595-8FC2-489C-9FA0-307C130A74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FD73-7408-405F-8F3A-83B50265A9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9345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5EB9D1-E94E-41E4-9380-77B038E4C8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4AF777-81BE-420E-92D6-5D4122B3D7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A4579DB-C298-4F77-B587-4166CB0F4B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01C9305-40B8-434A-A0A4-EE897EF7CC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AF4C315-9748-4B62-AE7F-C053109EE8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3FFB057-4373-4133-852F-0E1EB26E6B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C564-C670-4CB8-9A64-5039F3822A41}" type="datetimeFigureOut">
              <a:rPr lang="en-US" smtClean="0"/>
              <a:t>12/10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FEB904C-048B-47C2-A42D-727CE57CB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D34D6DD-83AA-471C-AD70-58CF666EA6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FD73-7408-405F-8F3A-83B50265A9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566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72AC06-8635-4C08-827B-1DF62996BF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6DBA60-D103-4C32-B851-BD854B53DA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C564-C670-4CB8-9A64-5039F3822A41}" type="datetimeFigureOut">
              <a:rPr lang="en-US" smtClean="0"/>
              <a:t>12/10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F64C6E-1122-4FD3-9407-89A452795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4D4256D-59D4-49B9-A0B9-69F8A97745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FD73-7408-405F-8F3A-83B50265A9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776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290E6B7-AF62-4B69-BD16-4DD793A50B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C564-C670-4CB8-9A64-5039F3822A41}" type="datetimeFigureOut">
              <a:rPr lang="en-US" smtClean="0"/>
              <a:t>12/10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D7CA21B-7D8F-4ADB-90EF-BF136E790B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55F76A4-CEBB-4307-B46B-0809D63273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FD73-7408-405F-8F3A-83B50265A9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000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118C91-5FC7-42AD-A3F3-7CF7033E99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2E8039-9A7F-40B9-A792-308F6677EF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EDE18D-03CA-4801-8372-C51507F1A6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B838D0-C58F-4401-8CD7-901F992B19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C564-C670-4CB8-9A64-5039F3822A41}" type="datetimeFigureOut">
              <a:rPr lang="en-US" smtClean="0"/>
              <a:t>12/10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22AD42-32DD-4A04-BF91-A937F8C7F7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157F0E-ED39-4B47-96F6-C0FBF52D5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FD73-7408-405F-8F3A-83B50265A9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725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BFE3BC-F767-4E63-8432-202AE74096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FB45080-CB1B-426C-A7F4-CAAF0A57CC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9E387B1-1F45-4AC0-849C-29DFB90E05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E50856-E875-4FA9-8400-6C00892240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C564-C670-4CB8-9A64-5039F3822A41}" type="datetimeFigureOut">
              <a:rPr lang="en-US" smtClean="0"/>
              <a:t>12/10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974473-2391-4CE0-930A-8E89E94FE8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020712-3171-4DA1-9C71-1FB4445688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FD73-7408-405F-8F3A-83B50265A9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909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16D346C-9D0A-4A39-9B07-647C954B85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54ABE5-6AD8-402E-A1F5-A0714385FE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73D343-0A91-4D57-A845-78FBFCC473B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DEC564-C670-4CB8-9A64-5039F3822A41}" type="datetimeFigureOut">
              <a:rPr lang="en-US" smtClean="0"/>
              <a:t>12/10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1B5A03-69DD-4AD7-A6E2-F3D5C0215E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B52891-07A3-418E-9B4C-A5622DE211C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89FD73-7408-405F-8F3A-83B50265A9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734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42887" y="4971739"/>
            <a:ext cx="1454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ell lysates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853361" y="5090163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ulture medium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459092" y="5924885"/>
            <a:ext cx="126188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B/ NL4-3</a:t>
            </a:r>
          </a:p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7398" y="6361672"/>
            <a:ext cx="19511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2A-B.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19792" y="405492"/>
            <a:ext cx="4539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2DD45FCE-5D39-478C-B256-E35634EF3BED}"/>
              </a:ext>
            </a:extLst>
          </p:cNvPr>
          <p:cNvGrpSpPr/>
          <p:nvPr/>
        </p:nvGrpSpPr>
        <p:grpSpPr>
          <a:xfrm>
            <a:off x="537279" y="847337"/>
            <a:ext cx="5655098" cy="4145946"/>
            <a:chOff x="657724" y="1196763"/>
            <a:chExt cx="5655098" cy="4145946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10944" y="1654265"/>
              <a:ext cx="3606959" cy="3688444"/>
            </a:xfrm>
            <a:prstGeom prst="rect">
              <a:avLst/>
            </a:prstGeom>
            <a:ln w="57150">
              <a:noFill/>
            </a:ln>
          </p:spPr>
        </p:pic>
        <p:sp>
          <p:nvSpPr>
            <p:cNvPr id="8" name="TextBox 7"/>
            <p:cNvSpPr txBox="1"/>
            <p:nvPr/>
          </p:nvSpPr>
          <p:spPr>
            <a:xfrm>
              <a:off x="657724" y="1196763"/>
              <a:ext cx="75212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ours </a:t>
              </a: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hase</a:t>
              </a:r>
            </a:p>
          </p:txBody>
        </p:sp>
        <p:sp>
          <p:nvSpPr>
            <p:cNvPr id="3" name="Rectangle 2"/>
            <p:cNvSpPr/>
            <p:nvPr/>
          </p:nvSpPr>
          <p:spPr>
            <a:xfrm>
              <a:off x="1539929" y="1639495"/>
              <a:ext cx="3546023" cy="3698422"/>
            </a:xfrm>
            <a:prstGeom prst="rect">
              <a:avLst/>
            </a:prstGeom>
            <a:noFill/>
            <a:ln w="571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673279" y="1266660"/>
              <a:ext cx="35433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    C       0       1      3       6    </a:t>
              </a:r>
            </a:p>
          </p:txBody>
        </p:sp>
        <p:cxnSp>
          <p:nvCxnSpPr>
            <p:cNvPr id="35" name="Straight Connector 34"/>
            <p:cNvCxnSpPr/>
            <p:nvPr/>
          </p:nvCxnSpPr>
          <p:spPr>
            <a:xfrm flipV="1">
              <a:off x="5121673" y="2033451"/>
              <a:ext cx="392655" cy="1316"/>
            </a:xfrm>
            <a:prstGeom prst="line">
              <a:avLst/>
            </a:prstGeom>
            <a:ln w="50800">
              <a:solidFill>
                <a:schemeClr val="tx1"/>
              </a:solidFill>
              <a:head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5461307" y="1814514"/>
              <a:ext cx="8515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gp160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455678" y="2155159"/>
              <a:ext cx="8515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gp120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476175" y="3433647"/>
              <a:ext cx="5822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p55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507823" y="4764627"/>
              <a:ext cx="5822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p24</a:t>
              </a:r>
            </a:p>
          </p:txBody>
        </p:sp>
        <p:cxnSp>
          <p:nvCxnSpPr>
            <p:cNvPr id="40" name="Straight Connector 39"/>
            <p:cNvCxnSpPr/>
            <p:nvPr/>
          </p:nvCxnSpPr>
          <p:spPr>
            <a:xfrm flipV="1">
              <a:off x="5114053" y="2321922"/>
              <a:ext cx="392655" cy="1316"/>
            </a:xfrm>
            <a:prstGeom prst="line">
              <a:avLst/>
            </a:prstGeom>
            <a:ln w="50800">
              <a:solidFill>
                <a:schemeClr val="tx1"/>
              </a:solidFill>
              <a:head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 flipV="1">
              <a:off x="5129293" y="3635828"/>
              <a:ext cx="392655" cy="1316"/>
            </a:xfrm>
            <a:prstGeom prst="line">
              <a:avLst/>
            </a:prstGeom>
            <a:ln w="50800">
              <a:solidFill>
                <a:schemeClr val="tx1"/>
              </a:solidFill>
              <a:head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 flipV="1">
              <a:off x="5136913" y="4971506"/>
              <a:ext cx="392655" cy="1316"/>
            </a:xfrm>
            <a:prstGeom prst="line">
              <a:avLst/>
            </a:prstGeom>
            <a:ln w="50800">
              <a:solidFill>
                <a:schemeClr val="tx1"/>
              </a:solidFill>
              <a:head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>
              <a:off x="1300843" y="2229938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1314451" y="2678960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>
              <a:off x="1301375" y="3766191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>
              <a:off x="1317173" y="3121478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>
              <a:off x="1330780" y="4816928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>
              <a:off x="1311730" y="4339881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/>
            <p:cNvSpPr txBox="1"/>
            <p:nvPr/>
          </p:nvSpPr>
          <p:spPr>
            <a:xfrm>
              <a:off x="813482" y="2059814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798242" y="2463674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904922" y="2966595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904922" y="3629535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935402" y="4208655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943022" y="4658235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7D836784-8635-48A3-98C9-7546C2DE4B96}"/>
              </a:ext>
            </a:extLst>
          </p:cNvPr>
          <p:cNvGrpSpPr/>
          <p:nvPr/>
        </p:nvGrpSpPr>
        <p:grpSpPr>
          <a:xfrm>
            <a:off x="6139039" y="848997"/>
            <a:ext cx="5311529" cy="4183474"/>
            <a:chOff x="6259484" y="1198423"/>
            <a:chExt cx="5311529" cy="4183474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079117" y="1632675"/>
              <a:ext cx="3228703" cy="3749222"/>
            </a:xfrm>
            <a:prstGeom prst="rect">
              <a:avLst/>
            </a:prstGeom>
            <a:ln w="57150">
              <a:solidFill>
                <a:schemeClr val="tx1"/>
              </a:solidFill>
            </a:ln>
          </p:spPr>
        </p:pic>
        <p:sp>
          <p:nvSpPr>
            <p:cNvPr id="12" name="Rectangle 11"/>
            <p:cNvSpPr/>
            <p:nvPr/>
          </p:nvSpPr>
          <p:spPr>
            <a:xfrm>
              <a:off x="7063633" y="1628078"/>
              <a:ext cx="3238500" cy="3744952"/>
            </a:xfrm>
            <a:prstGeom prst="rect">
              <a:avLst/>
            </a:prstGeom>
            <a:noFill/>
            <a:ln w="571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259484" y="1198423"/>
              <a:ext cx="72167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ours</a:t>
              </a: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hase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7191540" y="1271838"/>
              <a:ext cx="27238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   0      1       3      6       C</a:t>
              </a:r>
            </a:p>
          </p:txBody>
        </p:sp>
        <p:cxnSp>
          <p:nvCxnSpPr>
            <p:cNvPr id="43" name="Straight Connector 42"/>
            <p:cNvCxnSpPr/>
            <p:nvPr/>
          </p:nvCxnSpPr>
          <p:spPr>
            <a:xfrm flipV="1">
              <a:off x="10361278" y="2275697"/>
              <a:ext cx="392655" cy="1316"/>
            </a:xfrm>
            <a:prstGeom prst="line">
              <a:avLst/>
            </a:prstGeom>
            <a:ln w="50800">
              <a:solidFill>
                <a:schemeClr val="tx1"/>
              </a:solidFill>
              <a:head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>
              <a:off x="10719498" y="2055223"/>
              <a:ext cx="8515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gp120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0723214" y="4699417"/>
              <a:ext cx="5822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p24</a:t>
              </a:r>
            </a:p>
          </p:txBody>
        </p:sp>
        <p:cxnSp>
          <p:nvCxnSpPr>
            <p:cNvPr id="50" name="Straight Connector 49"/>
            <p:cNvCxnSpPr/>
            <p:nvPr/>
          </p:nvCxnSpPr>
          <p:spPr>
            <a:xfrm flipV="1">
              <a:off x="10331913" y="4936245"/>
              <a:ext cx="392655" cy="1316"/>
            </a:xfrm>
            <a:prstGeom prst="line">
              <a:avLst/>
            </a:prstGeom>
            <a:ln w="50800">
              <a:solidFill>
                <a:schemeClr val="tx1"/>
              </a:solidFill>
              <a:head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>
              <a:off x="6816979" y="2172696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>
              <a:off x="6819435" y="2742468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6817511" y="3729020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>
              <a:off x="6811007" y="3151214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/>
            <p:cNvCxnSpPr/>
            <p:nvPr/>
          </p:nvCxnSpPr>
          <p:spPr>
            <a:xfrm>
              <a:off x="6846916" y="4768606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6827866" y="4191198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9"/>
            <p:cNvSpPr txBox="1"/>
            <p:nvPr/>
          </p:nvSpPr>
          <p:spPr>
            <a:xfrm>
              <a:off x="6329618" y="2002572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6325529" y="2551398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6421058" y="300748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6432209" y="3558911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6462689" y="4026519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6459158" y="4609913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</p:grpSp>
      <p:sp>
        <p:nvSpPr>
          <p:cNvPr id="79" name="TextBox 78"/>
          <p:cNvSpPr txBox="1"/>
          <p:nvPr/>
        </p:nvSpPr>
        <p:spPr>
          <a:xfrm>
            <a:off x="6024777" y="390624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EAF9A19F-F4AD-498A-A8E8-F0DD2F28CD19}"/>
              </a:ext>
            </a:extLst>
          </p:cNvPr>
          <p:cNvSpPr/>
          <p:nvPr/>
        </p:nvSpPr>
        <p:spPr>
          <a:xfrm>
            <a:off x="1489538" y="5459495"/>
            <a:ext cx="3405914" cy="399275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A6773C1-E9C8-4D97-AD03-7864D601EB07}"/>
              </a:ext>
            </a:extLst>
          </p:cNvPr>
          <p:cNvSpPr txBox="1"/>
          <p:nvPr/>
        </p:nvSpPr>
        <p:spPr>
          <a:xfrm>
            <a:off x="325526" y="5446188"/>
            <a:ext cx="9370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D89C783F-E617-420C-9CE1-BC8EE1FDD544}"/>
              </a:ext>
            </a:extLst>
          </p:cNvPr>
          <p:cNvCxnSpPr/>
          <p:nvPr/>
        </p:nvCxnSpPr>
        <p:spPr>
          <a:xfrm>
            <a:off x="1131056" y="5655660"/>
            <a:ext cx="310718" cy="0"/>
          </a:xfrm>
          <a:prstGeom prst="line">
            <a:avLst/>
          </a:prstGeom>
          <a:ln w="381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9">
            <a:extLst>
              <a:ext uri="{FF2B5EF4-FFF2-40B4-BE49-F238E27FC236}">
                <a16:creationId xmlns:a16="http://schemas.microsoft.com/office/drawing/2014/main" id="{002D04A2-9EFB-499C-AE19-C4544BD2D85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89537" y="5485140"/>
            <a:ext cx="3405915" cy="358833"/>
          </a:xfrm>
          <a:prstGeom prst="rect">
            <a:avLst/>
          </a:prstGeom>
        </p:spPr>
      </p:pic>
      <p:sp>
        <p:nvSpPr>
          <p:cNvPr id="82" name="TextBox 81">
            <a:extLst>
              <a:ext uri="{FF2B5EF4-FFF2-40B4-BE49-F238E27FC236}">
                <a16:creationId xmlns:a16="http://schemas.microsoft.com/office/drawing/2014/main" id="{F9D94125-2A0A-43FE-80FB-8B8443517217}"/>
              </a:ext>
            </a:extLst>
          </p:cNvPr>
          <p:cNvSpPr txBox="1"/>
          <p:nvPr/>
        </p:nvSpPr>
        <p:spPr>
          <a:xfrm>
            <a:off x="5463680" y="6207827"/>
            <a:ext cx="1148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l-GR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HIV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83810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481B652D-B2D7-4DBA-AD81-3696D268D6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1938" y="5436882"/>
            <a:ext cx="3405914" cy="3683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431742" y="4901427"/>
            <a:ext cx="1454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ell lysates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984081" y="5053631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ulture medium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542025" y="5421395"/>
            <a:ext cx="126188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B/ NL4-3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-gB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0131" y="6334246"/>
            <a:ext cx="18806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2C-D.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019799" y="386442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41563" y="394607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0A4E09BB-A1DB-4548-9793-5E2CABC86629}"/>
              </a:ext>
            </a:extLst>
          </p:cNvPr>
          <p:cNvGrpSpPr/>
          <p:nvPr/>
        </p:nvGrpSpPr>
        <p:grpSpPr>
          <a:xfrm>
            <a:off x="6233930" y="693365"/>
            <a:ext cx="5105347" cy="4249605"/>
            <a:chOff x="6214880" y="1131515"/>
            <a:chExt cx="5105347" cy="4249605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117936" y="1657349"/>
              <a:ext cx="3267036" cy="3723771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6214880" y="1131515"/>
              <a:ext cx="77136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ours</a:t>
              </a: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Chase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256323" y="1262943"/>
              <a:ext cx="35433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   0       1       3       6        C</a:t>
              </a: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7127421" y="1641155"/>
              <a:ext cx="3254364" cy="3698422"/>
            </a:xfrm>
            <a:prstGeom prst="rect">
              <a:avLst/>
            </a:prstGeom>
            <a:noFill/>
            <a:ln w="571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cxnSp>
          <p:nvCxnSpPr>
            <p:cNvPr id="47" name="Straight Connector 46"/>
            <p:cNvCxnSpPr/>
            <p:nvPr/>
          </p:nvCxnSpPr>
          <p:spPr>
            <a:xfrm>
              <a:off x="6890823" y="2015731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6880109" y="2376111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6934002" y="3416598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>
              <a:off x="6890823" y="2876151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>
              <a:off x="6905665" y="4564482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>
              <a:off x="6905665" y="4084544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/>
            <p:cNvSpPr txBox="1"/>
            <p:nvPr/>
          </p:nvSpPr>
          <p:spPr>
            <a:xfrm>
              <a:off x="6329619" y="1846454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6314379" y="2250314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6421059" y="2661794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6421059" y="3324734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6451539" y="3903854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6459159" y="4353434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cxnSp>
          <p:nvCxnSpPr>
            <p:cNvPr id="59" name="Straight Connector 58"/>
            <p:cNvCxnSpPr/>
            <p:nvPr/>
          </p:nvCxnSpPr>
          <p:spPr>
            <a:xfrm flipV="1">
              <a:off x="10435129" y="2224142"/>
              <a:ext cx="392655" cy="1316"/>
            </a:xfrm>
            <a:prstGeom prst="line">
              <a:avLst/>
            </a:prstGeom>
            <a:ln w="50800">
              <a:solidFill>
                <a:schemeClr val="tx1"/>
              </a:solidFill>
              <a:head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/>
            <p:cNvSpPr txBox="1"/>
            <p:nvPr/>
          </p:nvSpPr>
          <p:spPr>
            <a:xfrm>
              <a:off x="10827784" y="2007297"/>
              <a:ext cx="4924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gB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3CA27276-B5A7-49C9-99DD-6491012E957F}"/>
              </a:ext>
            </a:extLst>
          </p:cNvPr>
          <p:cNvGrpSpPr/>
          <p:nvPr/>
        </p:nvGrpSpPr>
        <p:grpSpPr>
          <a:xfrm>
            <a:off x="665621" y="725161"/>
            <a:ext cx="5268266" cy="4179398"/>
            <a:chOff x="646571" y="1163311"/>
            <a:chExt cx="5268266" cy="4179398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517291" y="1631043"/>
              <a:ext cx="3462291" cy="3711666"/>
            </a:xfrm>
            <a:prstGeom prst="rect">
              <a:avLst/>
            </a:prstGeom>
            <a:ln w="57150">
              <a:noFill/>
            </a:ln>
          </p:spPr>
        </p:pic>
        <p:sp>
          <p:nvSpPr>
            <p:cNvPr id="8" name="TextBox 7"/>
            <p:cNvSpPr txBox="1"/>
            <p:nvPr/>
          </p:nvSpPr>
          <p:spPr>
            <a:xfrm>
              <a:off x="646571" y="1163311"/>
              <a:ext cx="72167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ours</a:t>
              </a: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hase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784791" y="1233207"/>
              <a:ext cx="35433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   0       1        3       6        C</a:t>
              </a:r>
            </a:p>
          </p:txBody>
        </p:sp>
        <p:sp>
          <p:nvSpPr>
            <p:cNvPr id="3" name="Rectangle 2"/>
            <p:cNvSpPr/>
            <p:nvPr/>
          </p:nvSpPr>
          <p:spPr>
            <a:xfrm>
              <a:off x="1517628" y="1628344"/>
              <a:ext cx="3433514" cy="3698422"/>
            </a:xfrm>
            <a:prstGeom prst="rect">
              <a:avLst/>
            </a:prstGeom>
            <a:noFill/>
            <a:ln w="571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cxnSp>
          <p:nvCxnSpPr>
            <p:cNvPr id="35" name="Straight Connector 34"/>
            <p:cNvCxnSpPr/>
            <p:nvPr/>
          </p:nvCxnSpPr>
          <p:spPr>
            <a:xfrm>
              <a:off x="1280731" y="1806631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1278010" y="2226260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1313920" y="3537192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>
              <a:off x="1272568" y="2876151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1286175" y="4571601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1307947" y="4102718"/>
              <a:ext cx="2122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768877" y="1636509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786293" y="2056699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860317" y="2721268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860317" y="3384208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890797" y="3963328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898417" y="4412908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cxnSp>
          <p:nvCxnSpPr>
            <p:cNvPr id="61" name="Straight Connector 60"/>
            <p:cNvCxnSpPr/>
            <p:nvPr/>
          </p:nvCxnSpPr>
          <p:spPr>
            <a:xfrm flipV="1">
              <a:off x="5061663" y="2231963"/>
              <a:ext cx="392655" cy="1316"/>
            </a:xfrm>
            <a:prstGeom prst="line">
              <a:avLst/>
            </a:prstGeom>
            <a:ln w="50800">
              <a:solidFill>
                <a:schemeClr val="tx1"/>
              </a:solidFill>
              <a:head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5422394" y="2015731"/>
              <a:ext cx="4924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gB</a:t>
              </a:r>
            </a:p>
          </p:txBody>
        </p:sp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D32C903E-908E-4AA8-84F2-18A85E548390}"/>
              </a:ext>
            </a:extLst>
          </p:cNvPr>
          <p:cNvSpPr txBox="1"/>
          <p:nvPr/>
        </p:nvSpPr>
        <p:spPr>
          <a:xfrm>
            <a:off x="336818" y="5421395"/>
            <a:ext cx="9370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8B40BBF9-C535-460C-912E-211FC59648F7}"/>
              </a:ext>
            </a:extLst>
          </p:cNvPr>
          <p:cNvCxnSpPr/>
          <p:nvPr/>
        </p:nvCxnSpPr>
        <p:spPr>
          <a:xfrm>
            <a:off x="1149213" y="5613697"/>
            <a:ext cx="310718" cy="0"/>
          </a:xfrm>
          <a:prstGeom prst="line">
            <a:avLst/>
          </a:prstGeom>
          <a:ln w="381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Rectangle 64">
            <a:extLst>
              <a:ext uri="{FF2B5EF4-FFF2-40B4-BE49-F238E27FC236}">
                <a16:creationId xmlns:a16="http://schemas.microsoft.com/office/drawing/2014/main" id="{540A53CF-5F4F-4E70-A303-4AD36FBE1C7A}"/>
              </a:ext>
            </a:extLst>
          </p:cNvPr>
          <p:cNvSpPr/>
          <p:nvPr/>
        </p:nvSpPr>
        <p:spPr>
          <a:xfrm>
            <a:off x="1641938" y="5421395"/>
            <a:ext cx="3405914" cy="399275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5790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5</Words>
  <Application>Microsoft Office PowerPoint</Application>
  <PresentationFormat>Widescreen</PresentationFormat>
  <Paragraphs>6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ward Stephens</dc:creator>
  <cp:lastModifiedBy>Edward Stephens</cp:lastModifiedBy>
  <cp:revision>1</cp:revision>
  <dcterms:created xsi:type="dcterms:W3CDTF">2018-12-10T20:35:00Z</dcterms:created>
  <dcterms:modified xsi:type="dcterms:W3CDTF">2018-12-10T20:35:36Z</dcterms:modified>
</cp:coreProperties>
</file>